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4" autoAdjust="0"/>
    <p:restoredTop sz="94660"/>
  </p:normalViewPr>
  <p:slideViewPr>
    <p:cSldViewPr snapToGrid="0">
      <p:cViewPr varScale="1">
        <p:scale>
          <a:sx n="91" d="100"/>
          <a:sy n="91" d="100"/>
        </p:scale>
        <p:origin x="42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488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269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00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924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907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19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404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3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461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006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DB79D-8A21-46BA-81BF-292A97540E9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21D23-C1F8-4068-98E5-AEA33752A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005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1318577" y="126063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10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430413" y="193899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8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443004" y="26340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6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433617" y="333616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4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426641" y="404444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2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518232" y="4733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986246" y="513199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912820" y="513199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24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903180" y="513199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48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937644" y="513199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72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920231" y="513199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96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870106" y="5131991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120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566497" y="5116602"/>
            <a:ext cx="993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cs typeface="Times New Roman" panose="02020603050405020304" pitchFamily="18" charset="0"/>
              </a:rPr>
              <a:t>Months</a:t>
            </a:r>
            <a:endParaRPr kumimoji="1" lang="ja-JP" altLang="en-US" sz="2000" dirty="0"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>
            <a:off x="2490523" y="4555242"/>
            <a:ext cx="666581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/>
          <p:cNvSpPr txBox="1"/>
          <p:nvPr/>
        </p:nvSpPr>
        <p:spPr>
          <a:xfrm>
            <a:off x="3242152" y="4370576"/>
            <a:ext cx="1113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CT (N=92)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>
            <a:off x="2500251" y="4185910"/>
            <a:ext cx="666581" cy="0"/>
          </a:xfrm>
          <a:prstGeom prst="line">
            <a:avLst/>
          </a:prstGeom>
          <a:ln w="571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3243398" y="4000401"/>
            <a:ext cx="1694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Non-CT (N=104)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651376" y="4294383"/>
            <a:ext cx="1871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Log-rank: P=0.539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40756" y="2867238"/>
            <a:ext cx="21739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cs typeface="Times New Roman" panose="02020603050405020304" pitchFamily="18" charset="0"/>
              </a:rPr>
              <a:t>Overall survival</a:t>
            </a:r>
            <a:endParaRPr kumimoji="1" lang="ja-JP" altLang="en-US" sz="2400" dirty="0"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825348" y="598744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8367386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>
                <a:cs typeface="Times New Roman" panose="02020603050405020304" pitchFamily="18" charset="0"/>
              </a:rPr>
              <a:t>Fig.S2 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31611" y="5188679"/>
            <a:ext cx="1111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umber at risk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112566" y="5602525"/>
            <a:ext cx="728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on-CT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470163" y="5405630"/>
            <a:ext cx="3699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T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971925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92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912820" y="55822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924013" y="55822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6</a:t>
            </a: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953294" y="55822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8</a:t>
            </a: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934377" y="55822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1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003140" y="55822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8</a:t>
            </a: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899229" y="55822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4</a:t>
            </a: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931496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80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923853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64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4962944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1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942206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6954264" y="53766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2</a:t>
            </a: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002509" y="3098097"/>
            <a:ext cx="1761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eighted cohort</a:t>
            </a: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8788" y="1260638"/>
            <a:ext cx="5637356" cy="3969628"/>
          </a:xfrm>
          <a:prstGeom prst="rect">
            <a:avLst/>
          </a:prstGeom>
        </p:spPr>
      </p:pic>
      <p:cxnSp>
        <p:nvCxnSpPr>
          <p:cNvPr id="61" name="直線コネクタ 60"/>
          <p:cNvCxnSpPr/>
          <p:nvPr/>
        </p:nvCxnSpPr>
        <p:spPr>
          <a:xfrm>
            <a:off x="2642923" y="4707642"/>
            <a:ext cx="666581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/>
          <p:cNvSpPr txBox="1"/>
          <p:nvPr/>
        </p:nvSpPr>
        <p:spPr>
          <a:xfrm>
            <a:off x="3394552" y="4522976"/>
            <a:ext cx="1113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CT (N=92)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cxnSp>
        <p:nvCxnSpPr>
          <p:cNvPr id="63" name="直線コネクタ 62"/>
          <p:cNvCxnSpPr/>
          <p:nvPr/>
        </p:nvCxnSpPr>
        <p:spPr>
          <a:xfrm>
            <a:off x="2652651" y="4338310"/>
            <a:ext cx="666581" cy="0"/>
          </a:xfrm>
          <a:prstGeom prst="line">
            <a:avLst/>
          </a:prstGeom>
          <a:ln w="571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/>
          <p:cNvSpPr txBox="1"/>
          <p:nvPr/>
        </p:nvSpPr>
        <p:spPr>
          <a:xfrm>
            <a:off x="3395798" y="4152801"/>
            <a:ext cx="1694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Non-CT (N=104)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695407" y="4458346"/>
            <a:ext cx="1871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Log-rank: P=0.539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154909" y="3250497"/>
            <a:ext cx="1348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PTW cohort</a:t>
            </a:r>
          </a:p>
        </p:txBody>
      </p:sp>
    </p:spTree>
    <p:extLst>
      <p:ext uri="{BB962C8B-B14F-4D97-AF65-F5344CB8AC3E}">
        <p14:creationId xmlns:p14="http://schemas.microsoft.com/office/powerpoint/2010/main" val="4208419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画面に合わせる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K</dc:creator>
  <cp:lastModifiedBy>梶山 広明</cp:lastModifiedBy>
  <cp:revision>3</cp:revision>
  <dcterms:created xsi:type="dcterms:W3CDTF">2019-12-28T23:49:48Z</dcterms:created>
  <dcterms:modified xsi:type="dcterms:W3CDTF">2020-03-09T06:44:45Z</dcterms:modified>
</cp:coreProperties>
</file>